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2803B8-2CE5-4058-94C0-669B3F8F8E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09E3F-1CA2-4D25-9F8A-21BA4C5145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AF642-966F-4885-835A-20550E5393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96CE2-77FD-4099-963E-AD23FAEFF4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2CFFB-363E-4FB6-BED5-3388E1162D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FCE45-689D-4A6D-A862-1C4E6DD330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25D8A-FCBF-401B-90ED-17F4B5BD40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E5A99-2A90-4D8D-8D72-9BC5C5715E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D51AB1-A97C-45C9-BC53-6208EBF21E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D83E5-E7B0-4E25-98A4-CBAD32DBE6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CD19F-9C27-4CA3-BF7B-E1AFAC2BD3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E01BA-7510-40B7-ADA0-44E095B675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D1ED3A-CA06-4450-BDD2-F0CBFF42F627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290840" y="40968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290840" y="85104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290840" y="117144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290840" y="160956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2766960" y="2352600"/>
            <a:ext cx="73332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529080" y="628560"/>
            <a:ext cx="0" cy="7621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2081160" y="1828800"/>
            <a:ext cx="0" cy="12193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2081160" y="3962520"/>
            <a:ext cx="0" cy="1295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290840" y="399960"/>
            <a:ext cx="0" cy="457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3529080" y="638280"/>
            <a:ext cx="761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529080" y="1380960"/>
            <a:ext cx="761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2081160" y="183816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2766960" y="1004760"/>
            <a:ext cx="762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2081160" y="3038400"/>
            <a:ext cx="2666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1319040" y="2448000"/>
            <a:ext cx="762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529080" y="4191120"/>
            <a:ext cx="121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2081160" y="3962520"/>
            <a:ext cx="1447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04640" y="3581280"/>
            <a:ext cx="9144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766960" y="4962600"/>
            <a:ext cx="762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290840" y="1162080"/>
            <a:ext cx="0" cy="457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1319040" y="2438280"/>
            <a:ext cx="0" cy="22100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2766960" y="4952880"/>
            <a:ext cx="0" cy="198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3529080" y="4724280"/>
            <a:ext cx="0" cy="6098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3529080" y="5334120"/>
            <a:ext cx="761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766960" y="6477120"/>
            <a:ext cx="1981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2766960" y="6019920"/>
            <a:ext cx="1981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824360" y="24768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YK-4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824360" y="62856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J-138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824360" y="207000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DC-9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824360" y="139068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M-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4824360" y="100980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AR-39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4824360" y="243828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IOL-207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824360" y="2819520"/>
            <a:ext cx="152388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TW-183, A-03, UZG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824360" y="3429000"/>
            <a:ext cx="152388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300" spc="-1" strike="noStrike">
                <a:solidFill>
                  <a:srgbClr val="000000"/>
                </a:solidFill>
                <a:latin typeface="Arial"/>
              </a:rPr>
              <a:t>Panola, 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300" spc="-1" strike="noStrike">
                <a:solidFill>
                  <a:srgbClr val="000000"/>
                </a:solidFill>
                <a:latin typeface="Arial"/>
              </a:rPr>
              <a:t>Kajaani-6, -7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4824360" y="403848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Helsinki-12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4824360" y="4844880"/>
            <a:ext cx="152388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W-6, U-1273, U127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4824360" y="457200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T-45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4824360" y="586728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V-14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4824360" y="632448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WL-011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2766960" y="6705720"/>
            <a:ext cx="3048120" cy="10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WL-029, CV-15, CV-16, CV-17, CV-18, Wien-2, Wien-3, MUL-2216, MUL-2076, MUL-2090, MUL-250, PB-1, PB-2, PB-3, AL-1, U-1360, W-5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3605040" y="39996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513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2852640" y="213372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14293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3529080" y="1162080"/>
            <a:ext cx="83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14293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2766960" y="78120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96183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2081160" y="1523880"/>
            <a:ext cx="60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124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1243080" y="2019240"/>
            <a:ext cx="60948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020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469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404640" y="3162240"/>
            <a:ext cx="60984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134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110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2538360" y="373392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11265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2766960" y="472428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11280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2004840" y="5257800"/>
            <a:ext cx="83844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11217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11265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1319040" y="4267080"/>
            <a:ext cx="60984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6353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8515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2919240" y="579132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513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2919240" y="624852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4449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4062240" y="24768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3284640" y="243216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274920" y="188136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4062240" y="146700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4062240" y="100980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4062240" y="70488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1814400" y="2666880"/>
            <a:ext cx="228600" cy="47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1805040" y="1752480"/>
            <a:ext cx="228600" cy="47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2538360" y="213372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2538360" y="114300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3300480" y="123840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3300480" y="55260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3224160" y="411480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3224160" y="364176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1852560" y="4876920"/>
            <a:ext cx="228600" cy="47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2538360" y="4800600"/>
            <a:ext cx="22860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3300480" y="516564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3300480" y="457200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1852560" y="3886200"/>
            <a:ext cx="228600" cy="47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1014480" y="4114800"/>
            <a:ext cx="228600" cy="47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1014480" y="2438280"/>
            <a:ext cx="228600" cy="477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2538360" y="5524560"/>
            <a:ext cx="228600" cy="42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18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3516480" y="624852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3510000" y="579132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1319040" y="4641840"/>
            <a:ext cx="762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2081160" y="5257800"/>
            <a:ext cx="6858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3529080" y="4724280"/>
            <a:ext cx="121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4824360" y="542448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CWL-050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4290840" y="509904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4290840" y="553716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4290840" y="5089680"/>
            <a:ext cx="0" cy="457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4062240" y="539424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4062240" y="493704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3605040" y="510552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5874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2722680" y="653724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2716200" y="603900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3529080" y="3733920"/>
            <a:ext cx="1218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3529080" y="3733920"/>
            <a:ext cx="0" cy="457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0" y="9631440"/>
            <a:ext cx="320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Times New Roman"/>
              </a:rPr>
              <a:t>Rattei et al: Supplementary file 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4818240" y="1712880"/>
            <a:ext cx="15238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1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Koala</a:t>
            </a:r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3500280" y="2073240"/>
            <a:ext cx="0" cy="509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4292640" y="185724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4292640" y="229536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4292640" y="1847880"/>
            <a:ext cx="0" cy="4572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3500280" y="2073240"/>
            <a:ext cx="792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3500280" y="2576520"/>
            <a:ext cx="1290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2771640" y="996840"/>
            <a:ext cx="0" cy="1368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6019920" y="190512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Cluster I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6019920" y="1779480"/>
            <a:ext cx="0" cy="5320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5875200" y="177948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5875200" y="231300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5992920" y="84924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Cluster III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6006960" y="344520"/>
            <a:ext cx="0" cy="12952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5848200" y="34452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5848200" y="163980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5992920" y="269244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Cluster II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6021360" y="2422440"/>
            <a:ext cx="0" cy="91116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5877000" y="24224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5877000" y="33210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5992920" y="372888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de-DE" sz="1000" spc="-1" strike="noStrike">
                <a:solidFill>
                  <a:srgbClr val="000000"/>
                </a:solidFill>
                <a:latin typeface="Arial"/>
              </a:rPr>
              <a:t>Cluster IV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6021360" y="3459240"/>
            <a:ext cx="0" cy="91116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5877000" y="34592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5877000" y="43578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5992920" y="495288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de-DE" sz="1000" spc="-1" strike="noStrike">
                <a:solidFill>
                  <a:srgbClr val="000000"/>
                </a:solidFill>
                <a:latin typeface="Arial"/>
              </a:rPr>
              <a:t>Cluster IV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6021360" y="4592520"/>
            <a:ext cx="0" cy="10810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5877000" y="45925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5877000" y="567216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5992920" y="6681960"/>
            <a:ext cx="86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de-DE" sz="1000" spc="-1" strike="noStrike">
                <a:solidFill>
                  <a:srgbClr val="000000"/>
                </a:solidFill>
                <a:latin typeface="Arial"/>
              </a:rPr>
              <a:t>Cluster IVa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6021360" y="5907240"/>
            <a:ext cx="0" cy="18540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5877000" y="59072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5877000" y="77612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3573360" y="1857240"/>
            <a:ext cx="838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3853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4062240" y="171288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4062240" y="2216160"/>
            <a:ext cx="22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1-25T17:55:21Z</dcterms:created>
  <dc:creator>jg</dc:creator>
  <dc:description/>
  <dc:language>en-US</dc:language>
  <cp:lastModifiedBy>ok</cp:lastModifiedBy>
  <dcterms:modified xsi:type="dcterms:W3CDTF">2007-04-11T19:47:33Z</dcterms:modified>
  <cp:revision>17</cp:revision>
  <dc:subject/>
  <dc:title>PowerPoint-Präsentation</dc:title>
</cp:coreProperties>
</file>